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BF0D91-D58C-4484-9D47-A28BBA9BFD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5B8A6-655B-4790-A894-FC3990DDC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FF9792-6140-4760-B7AA-C5E6E639FD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77562-A930-490D-8921-A75C1F33A2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6174E-7FF6-4D21-ABEB-B5E3174F76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C56C3-ABEB-499C-94CA-032E27DF80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2DF31-185E-4C0B-8E74-67CCD7DE0C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9004A-2F3C-47B6-8CDF-8327270929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07300-6A2F-42D4-91B0-1BE2F3535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6D5F6-848B-4504-B5D4-7225ACDF44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0F758-1011-4059-9FD5-4851031201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7CE14-217A-4BF2-981A-D560BA46F3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1FB1B2-32C9-4A91-BC5E-C734EB21E6B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414720" y="428760"/>
            <a:ext cx="5755680" cy="33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A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Bias plots  for Marioni data  (procedure 1, gene-level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285840" y="1143000"/>
            <a:ext cx="8534160" cy="492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2"/>
          <p:cNvSpPr/>
          <p:nvPr/>
        </p:nvSpPr>
        <p:spPr>
          <a:xfrm>
            <a:off x="428760" y="428760"/>
            <a:ext cx="7235640" cy="33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B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Bias plots  for Mamanova data  (procedure 1, gene-level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285840" y="1149480"/>
            <a:ext cx="8542080" cy="492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2"/>
          <p:cNvSpPr/>
          <p:nvPr/>
        </p:nvSpPr>
        <p:spPr>
          <a:xfrm>
            <a:off x="437400" y="428760"/>
            <a:ext cx="5362200" cy="33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C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Bias plots  for Lee data  (procedure 1, gene-level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428760" y="1143000"/>
            <a:ext cx="8550000" cy="492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2"/>
          <p:cNvSpPr/>
          <p:nvPr/>
        </p:nvSpPr>
        <p:spPr>
          <a:xfrm>
            <a:off x="437400" y="428760"/>
            <a:ext cx="6133680" cy="33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D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Bias plots  for Nagalakshmi data  (procedure 1, gene-level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260280" y="1143000"/>
            <a:ext cx="8526600" cy="492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1:46Z</dcterms:created>
  <dc:creator>Wei Zheng</dc:creator>
  <dc:description/>
  <dc:language>en-US</dc:language>
  <cp:lastModifiedBy>Wei Zheng</cp:lastModifiedBy>
  <dcterms:modified xsi:type="dcterms:W3CDTF">2011-06-06T17:23:29Z</dcterms:modified>
  <cp:revision>1</cp:revision>
  <dc:subject/>
  <dc:title>Slide 1</dc:title>
</cp:coreProperties>
</file>